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923FF-9FE0-40E2-B5F7-549BE5C2438F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0A8DA-09D0-4CF7-ADA6-E49326FD319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5387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923FF-9FE0-40E2-B5F7-549BE5C2438F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0A8DA-09D0-4CF7-ADA6-E49326FD319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7513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923FF-9FE0-40E2-B5F7-549BE5C2438F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0A8DA-09D0-4CF7-ADA6-E49326FD319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320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923FF-9FE0-40E2-B5F7-549BE5C2438F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0A8DA-09D0-4CF7-ADA6-E49326FD319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029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923FF-9FE0-40E2-B5F7-549BE5C2438F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0A8DA-09D0-4CF7-ADA6-E49326FD319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2552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923FF-9FE0-40E2-B5F7-549BE5C2438F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0A8DA-09D0-4CF7-ADA6-E49326FD319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9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923FF-9FE0-40E2-B5F7-549BE5C2438F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0A8DA-09D0-4CF7-ADA6-E49326FD319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245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923FF-9FE0-40E2-B5F7-549BE5C2438F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0A8DA-09D0-4CF7-ADA6-E49326FD319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126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923FF-9FE0-40E2-B5F7-549BE5C2438F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0A8DA-09D0-4CF7-ADA6-E49326FD319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868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923FF-9FE0-40E2-B5F7-549BE5C2438F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0A8DA-09D0-4CF7-ADA6-E49326FD319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099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9923FF-9FE0-40E2-B5F7-549BE5C2438F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0A8DA-09D0-4CF7-ADA6-E49326FD319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20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9923FF-9FE0-40E2-B5F7-549BE5C2438F}" type="datetimeFigureOut">
              <a:rPr lang="en-US" smtClean="0"/>
              <a:t>1/10/2018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80A8DA-09D0-4CF7-ADA6-E49326FD319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2266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0498" y="1237956"/>
            <a:ext cx="9481625" cy="5333414"/>
          </a:xfrm>
          <a:prstGeom prst="rect">
            <a:avLst/>
          </a:prstGeom>
        </p:spPr>
      </p:pic>
      <p:sp>
        <p:nvSpPr>
          <p:cNvPr id="6" name="Rettangolo 5"/>
          <p:cNvSpPr/>
          <p:nvPr/>
        </p:nvSpPr>
        <p:spPr>
          <a:xfrm>
            <a:off x="1350498" y="222293"/>
            <a:ext cx="967857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 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|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field trial was conducted at Maricopa Agricultural Cente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uthward view) la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33.070° N, long. 111.974° W, elev. 360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a Casa Grande sandy loam soil (fine-loamy, mixed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eractiv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ertherm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yp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trargid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 material included 248 accessions of durum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eat “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rum pane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”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ing a large portion of the genetic diversity present in the most important improved durum wheat gene pools.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03912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Emanuele Condorelli</dc:creator>
  <cp:lastModifiedBy>Giuseppe Emanuele Condorelli</cp:lastModifiedBy>
  <cp:revision>5</cp:revision>
  <dcterms:created xsi:type="dcterms:W3CDTF">2017-12-31T17:45:23Z</dcterms:created>
  <dcterms:modified xsi:type="dcterms:W3CDTF">2018-01-10T21:11:39Z</dcterms:modified>
</cp:coreProperties>
</file>